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1F71EA-EC7E-44FD-BDB7-6479BEA6A3A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BC3846-52C9-4B21-9E5F-159A8D8B9A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C0378D-4C3A-43D4-B3F9-896D851018A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7EE69B-DE37-44A4-8068-63B57FAAD00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D2463D-E34D-4BE1-BACC-92828F2F06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E03A53-6421-45D1-ADC8-00F2BB956D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5F7D0-621E-448B-B68D-94E5AC77CD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4C79DD-B7DD-4A14-A26D-CEA6C468DE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7125E7-DAC1-4B53-854C-C238DB6229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B679C0-D65D-44B6-B6E6-4E6AA86DCE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4CA682-866A-4E3E-83E3-DEC19590D5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4C0CE8-4B5D-4259-9D60-516D7171E1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529A36E-E3EA-4B65-AA9A-CF3442F2FCF3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CEBDB8B-A172-47F7-B5E9-D5FD2D9A50D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Oval 3"/>
          <p:cNvSpPr/>
          <p:nvPr/>
        </p:nvSpPr>
        <p:spPr>
          <a:xfrm>
            <a:off x="1406520" y="1538280"/>
            <a:ext cx="3168720" cy="2843280"/>
          </a:xfrm>
          <a:prstGeom prst="ellipse">
            <a:avLst/>
          </a:prstGeom>
          <a:gradFill rotWithShape="0">
            <a:gsLst>
              <a:gs pos="0">
                <a:srgbClr val="9bc1ff"/>
              </a:gs>
              <a:gs pos="100000">
                <a:srgbClr val="3f80cd"/>
              </a:gs>
            </a:gsLst>
            <a:lin ang="5400000"/>
          </a:gra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Oval 4"/>
          <p:cNvSpPr/>
          <p:nvPr/>
        </p:nvSpPr>
        <p:spPr>
          <a:xfrm>
            <a:off x="3143160" y="1585800"/>
            <a:ext cx="3170160" cy="2843280"/>
          </a:xfrm>
          <a:prstGeom prst="ellipse">
            <a:avLst/>
          </a:prstGeom>
          <a:solidFill>
            <a:srgbClr val="4f81bd">
              <a:alpha val="19000"/>
            </a:srgbClr>
          </a:soli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Oval 5"/>
          <p:cNvSpPr/>
          <p:nvPr/>
        </p:nvSpPr>
        <p:spPr>
          <a:xfrm>
            <a:off x="3178080" y="2727360"/>
            <a:ext cx="1187640" cy="1176480"/>
          </a:xfrm>
          <a:prstGeom prst="ellipse">
            <a:avLst/>
          </a:prstGeom>
          <a:solidFill>
            <a:srgbClr val="ff0000">
              <a:alpha val="19000"/>
            </a:srgbClr>
          </a:soli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Oval 6"/>
          <p:cNvSpPr/>
          <p:nvPr/>
        </p:nvSpPr>
        <p:spPr>
          <a:xfrm>
            <a:off x="3713040" y="1935000"/>
            <a:ext cx="547920" cy="466920"/>
          </a:xfrm>
          <a:prstGeom prst="ellipse">
            <a:avLst/>
          </a:prstGeom>
          <a:solidFill>
            <a:srgbClr val="008000">
              <a:alpha val="19000"/>
            </a:srgbClr>
          </a:solidFill>
          <a:ln w="9360">
            <a:solidFill>
              <a:srgbClr val="4a7ebb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85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8"/>
          <p:cNvSpPr/>
          <p:nvPr/>
        </p:nvSpPr>
        <p:spPr>
          <a:xfrm>
            <a:off x="3472920" y="3159000"/>
            <a:ext cx="644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735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9"/>
          <p:cNvSpPr/>
          <p:nvPr/>
        </p:nvSpPr>
        <p:spPr>
          <a:xfrm>
            <a:off x="4942080" y="2789280"/>
            <a:ext cx="759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158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0"/>
          <p:cNvSpPr/>
          <p:nvPr/>
        </p:nvSpPr>
        <p:spPr>
          <a:xfrm>
            <a:off x="1935360" y="2789280"/>
            <a:ext cx="759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000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Straight Connector 12"/>
          <p:cNvSpPr/>
          <p:nvPr/>
        </p:nvSpPr>
        <p:spPr>
          <a:xfrm flipV="1">
            <a:off x="1406520" y="1058400"/>
            <a:ext cx="2959200" cy="11160"/>
          </a:xfrm>
          <a:prstGeom prst="line">
            <a:avLst/>
          </a:prstGeom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Straight Connector 13"/>
          <p:cNvSpPr/>
          <p:nvPr/>
        </p:nvSpPr>
        <p:spPr>
          <a:xfrm flipV="1">
            <a:off x="3352680" y="4992480"/>
            <a:ext cx="2960640" cy="12600"/>
          </a:xfrm>
          <a:prstGeom prst="line">
            <a:avLst/>
          </a:prstGeom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4"/>
          <p:cNvSpPr/>
          <p:nvPr/>
        </p:nvSpPr>
        <p:spPr>
          <a:xfrm>
            <a:off x="1489680" y="696960"/>
            <a:ext cx="2719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llumina Indel calls (32,564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5"/>
          <p:cNvSpPr/>
          <p:nvPr/>
        </p:nvSpPr>
        <p:spPr>
          <a:xfrm>
            <a:off x="3322440" y="4957920"/>
            <a:ext cx="2773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apillary Indel calls (24,142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6"/>
          <p:cNvSpPr/>
          <p:nvPr/>
        </p:nvSpPr>
        <p:spPr>
          <a:xfrm>
            <a:off x="3894120" y="1131840"/>
            <a:ext cx="5083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ndel called as a deletion in Illumina data but as an insertion in the capillary data or an insertion in the Illumina data and as a deletion in the capillary dat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7"/>
          <p:cNvSpPr/>
          <p:nvPr/>
        </p:nvSpPr>
        <p:spPr>
          <a:xfrm>
            <a:off x="231840" y="4549680"/>
            <a:ext cx="65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Indel in the correct position but the base change predicted different between the Illumina data and capillary dat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4" name="Straight Arrow Connector 19"/>
          <p:cNvCxnSpPr>
            <a:stCxn id="52" idx="1"/>
            <a:endCxn id="44" idx="0"/>
          </p:cNvCxnSpPr>
          <p:nvPr/>
        </p:nvCxnSpPr>
        <p:spPr>
          <a:xfrm>
            <a:off x="3894120" y="1361160"/>
            <a:ext cx="93240" cy="5742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5" name="Straight Arrow Connector 20"/>
          <p:cNvCxnSpPr/>
          <p:nvPr/>
        </p:nvCxnSpPr>
        <p:spPr>
          <a:xfrm flipV="1">
            <a:off x="2700360" y="3599640"/>
            <a:ext cx="759600" cy="9500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6" name="TextBox 23"/>
          <p:cNvSpPr/>
          <p:nvPr/>
        </p:nvSpPr>
        <p:spPr>
          <a:xfrm>
            <a:off x="231840" y="700200"/>
            <a:ext cx="49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/J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4"/>
          <p:cNvSpPr/>
          <p:nvPr/>
        </p:nvSpPr>
        <p:spPr>
          <a:xfrm>
            <a:off x="154080" y="136440"/>
            <a:ext cx="475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dditional File 3: Summary of Indel call analysis: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8"/>
          <p:cNvSpPr/>
          <p:nvPr/>
        </p:nvSpPr>
        <p:spPr>
          <a:xfrm>
            <a:off x="414360" y="5635800"/>
            <a:ext cx="8323200" cy="11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Deep short-read sequencing of chromosome 17 from the mouse strains A/J and CAST/Ei identifies significant germline variation and candidate genes that regulate liver triglyceride levels.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Ian Sudbery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1§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, Jim Stalke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1§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, Jared T. Simpson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, Thomas Kean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, Alistair G. Rust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, Matthew E. Hurles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, Klaudia Walters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, Dee Lynch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, Lydia Teboul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, Steve Brown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, Heng Li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, Zemin Ning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, Joseph H. Nadeau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, Colleen M. Cronige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, Richard Durbin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, David J. Adams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1*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1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The Wellcome Trust Sanger Institute, Hinxton, UK.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MRC-Harwell, Oxfordshire, UK.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3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ase Western Reserve University, Cleveland, OH, USA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§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These authors contributed equally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ddress for Correspondence</a:t>
            </a:r>
            <a:r>
              <a:rPr b="1" lang="en-US" sz="1000" spc="-1" strike="noStrike" baseline="30000">
                <a:solidFill>
                  <a:srgbClr val="000000"/>
                </a:solidFill>
                <a:latin typeface="Calibri"/>
              </a:rPr>
              <a:t>*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Dr. David J. Adams Experimental Cancer Genetics Wellcome Trust Sanger Institute Wellcome Trust Genome Campus Hinxton, Cambridge, CB10 1HH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Ph: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+44 (0) 1223 834 244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Fax: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+44 (0) 1223 494919 </a:t>
            </a:r>
            <a:r>
              <a:rPr b="0" i="1" lang="en-US" sz="1000" spc="-1" strike="noStrike">
                <a:solidFill>
                  <a:srgbClr val="000000"/>
                </a:solidFill>
                <a:latin typeface="Calibri"/>
              </a:rPr>
              <a:t>Email: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da1@sanger.ac.uk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23T18:42:33Z</dcterms:created>
  <dc:creator>Sanger Institute</dc:creator>
  <dc:description/>
  <dc:language>en-US</dc:language>
  <cp:lastModifiedBy>Sanger Institute</cp:lastModifiedBy>
  <dcterms:modified xsi:type="dcterms:W3CDTF">2009-09-16T18:46:19Z</dcterms:modified>
  <cp:revision>16</cp:revision>
  <dc:subject/>
  <dc:title>Slide 1</dc:title>
</cp:coreProperties>
</file>